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9294813" cy="7008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F407B3-7CDF-4CDA-8DCF-D041F45289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2972D-342B-40CA-875A-CA8366D8B4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554A7A-7F2B-48E4-90C9-2DB41E87802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AF30C4-7FA4-4547-A0A3-8908ACED59F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DB88E9-646A-494E-A666-058F69A675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BE5C3A-AC15-4FDB-BA67-38D121DF74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16E26A-4FD3-44F0-B336-F6579BA272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1F131A-D32F-42CC-BB2B-A10EAE549B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8FD912-E59D-426C-8FEF-9233E18425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E480E9-BF92-4BA1-8E43-81C99D6E95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5261BC-001D-4651-964B-CD484CC231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C1B2DD-F402-4D16-8B34-7C35301AEA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8659DFB-99BD-428D-831A-CFFBA0401DF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7"/>
          <p:cNvSpPr/>
          <p:nvPr/>
        </p:nvSpPr>
        <p:spPr>
          <a:xfrm>
            <a:off x="6550200" y="1033560"/>
            <a:ext cx="228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0PP-20NM vs. Sang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8"/>
          <p:cNvSpPr/>
          <p:nvPr/>
        </p:nvSpPr>
        <p:spPr>
          <a:xfrm>
            <a:off x="3583800" y="1033560"/>
            <a:ext cx="228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5PP-15NM vs. Sang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ectangle 10"/>
          <p:cNvSpPr/>
          <p:nvPr/>
        </p:nvSpPr>
        <p:spPr>
          <a:xfrm>
            <a:off x="479520" y="1033560"/>
            <a:ext cx="228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0PP-10NM vs. Sang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itle 18"/>
          <p:cNvSpPr/>
          <p:nvPr/>
        </p:nvSpPr>
        <p:spPr>
          <a:xfrm>
            <a:off x="177840" y="4975200"/>
            <a:ext cx="8442360" cy="6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9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dditional Figure S1. Unmated Singletons plus Mate Pairs Can Substitute for Linear Reads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 Shown are read mix assemblies (MUMMER plots) aligned to the Sanger reference pseudomolecule where reads came from true mate pairs (PP) or cases where a read had no matching mate (NM). Red/blue indicate an inverted orientation relative to the reference sequenc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Picture 2" descr=""/>
          <p:cNvPicPr/>
          <p:nvPr/>
        </p:nvPicPr>
        <p:blipFill>
          <a:blip r:embed="rId1"/>
          <a:stretch/>
        </p:blipFill>
        <p:spPr>
          <a:xfrm>
            <a:off x="19080" y="1403280"/>
            <a:ext cx="3006720" cy="300672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3" descr=""/>
          <p:cNvPicPr/>
          <p:nvPr/>
        </p:nvPicPr>
        <p:blipFill>
          <a:blip r:embed="rId2"/>
          <a:stretch/>
        </p:blipFill>
        <p:spPr>
          <a:xfrm>
            <a:off x="3094200" y="1403280"/>
            <a:ext cx="3004920" cy="300672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4" descr=""/>
          <p:cNvPicPr/>
          <p:nvPr/>
        </p:nvPicPr>
        <p:blipFill>
          <a:blip r:embed="rId3"/>
          <a:stretch/>
        </p:blipFill>
        <p:spPr>
          <a:xfrm>
            <a:off x="6099120" y="1403280"/>
            <a:ext cx="3006720" cy="3006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8T20:19:09Z</dcterms:created>
  <dc:creator>Christopher Saski</dc:creator>
  <dc:description/>
  <dc:language>en-US</dc:language>
  <cp:lastModifiedBy>feltus</cp:lastModifiedBy>
  <cp:lastPrinted>2011-01-13T19:51:43Z</cp:lastPrinted>
  <dcterms:modified xsi:type="dcterms:W3CDTF">2011-04-04T18:37:04Z</dcterms:modified>
  <cp:revision>145</cp:revision>
  <dc:subject/>
  <dc:title>Pilot Project Update:</dc:title>
</cp:coreProperties>
</file>